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6" r:id="rId2"/>
    <p:sldId id="264" r:id="rId3"/>
    <p:sldId id="257" r:id="rId4"/>
    <p:sldId id="265" r:id="rId5"/>
    <p:sldId id="266" r:id="rId6"/>
    <p:sldId id="267" r:id="rId7"/>
    <p:sldId id="269" r:id="rId8"/>
    <p:sldId id="270" r:id="rId9"/>
    <p:sldId id="271" r:id="rId10"/>
    <p:sldId id="272" r:id="rId11"/>
    <p:sldId id="273" r:id="rId12"/>
    <p:sldId id="268" r:id="rId13"/>
    <p:sldId id="258" r:id="rId14"/>
    <p:sldId id="259" r:id="rId15"/>
    <p:sldId id="260" r:id="rId16"/>
    <p:sldId id="261" r:id="rId17"/>
    <p:sldId id="262" r:id="rId18"/>
    <p:sldId id="263" r:id="rId1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22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>
      <p:cViewPr>
        <p:scale>
          <a:sx n="50" d="100"/>
          <a:sy n="50" d="100"/>
        </p:scale>
        <p:origin x="2774" y="178"/>
      </p:cViewPr>
      <p:guideLst>
        <p:guide orient="horz" pos="3120"/>
        <p:guide pos="2160"/>
        <p:guide pos="22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B9B05C-A9A1-4AAA-A80B-5D501FD26379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CAA055-B22D-4BE6-936C-9B1E5EED4482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8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8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3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20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3CA9D6-B8EC-42B6-888F-2259F2854156}" type="datetimeFigureOut">
              <a:rPr lang="en-US" smtClean="0"/>
              <a:t>11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CD7EC2-19F3-4484-8CC4-37348056073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4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7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0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3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6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906B681-C088-3420-A9D7-AE312DC7777B}"/>
              </a:ext>
            </a:extLst>
          </p:cNvPr>
          <p:cNvSpPr txBox="1"/>
          <p:nvPr/>
        </p:nvSpPr>
        <p:spPr>
          <a:xfrm>
            <a:off x="188640" y="58257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97A3A31-6659-76DF-3774-DA444D6DB70F}"/>
              </a:ext>
            </a:extLst>
          </p:cNvPr>
          <p:cNvSpPr txBox="1"/>
          <p:nvPr/>
        </p:nvSpPr>
        <p:spPr>
          <a:xfrm>
            <a:off x="116632" y="345449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FA91EFC-70CB-93A0-C313-65B9964C5CBC}"/>
              </a:ext>
            </a:extLst>
          </p:cNvPr>
          <p:cNvSpPr txBox="1"/>
          <p:nvPr/>
        </p:nvSpPr>
        <p:spPr>
          <a:xfrm>
            <a:off x="260648" y="7257259"/>
            <a:ext cx="6408712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| Stratified analysis of alpha diversity by gender in healthy and SAM children.</a:t>
            </a:r>
            <a:b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plots depicting alpha diversity metrics (Chao1, Shannon, and Simpson indices) i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childre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ross healthy and SAM group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sponding alpha diversity comparisons i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childre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xplots display the median, interquartile range (IQR), and individual data points. P values were calculated using the Wilcoxon rank-sum test.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Chao1_Male.png">
            <a:extLst>
              <a:ext uri="{FF2B5EF4-FFF2-40B4-BE49-F238E27FC236}">
                <a16:creationId xmlns:a16="http://schemas.microsoft.com/office/drawing/2014/main" id="{F07A26DA-3B2B-DF8D-077A-A60FC09E60BC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3064" y="775917"/>
            <a:ext cx="2088000" cy="2951483"/>
          </a:xfrm>
          <a:prstGeom prst="rect">
            <a:avLst/>
          </a:prstGeom>
        </p:spPr>
      </p:pic>
      <p:pic>
        <p:nvPicPr>
          <p:cNvPr id="6" name="Picture 5" descr="Shannon_Male.png">
            <a:extLst>
              <a:ext uri="{FF2B5EF4-FFF2-40B4-BE49-F238E27FC236}">
                <a16:creationId xmlns:a16="http://schemas.microsoft.com/office/drawing/2014/main" id="{88918713-463C-A83E-B6E9-56A39565E22D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302774" y="775917"/>
            <a:ext cx="2088000" cy="2951483"/>
          </a:xfrm>
          <a:prstGeom prst="rect">
            <a:avLst/>
          </a:prstGeom>
        </p:spPr>
      </p:pic>
      <p:pic>
        <p:nvPicPr>
          <p:cNvPr id="7" name="Picture 6" descr="Simpson_Male.png">
            <a:extLst>
              <a:ext uri="{FF2B5EF4-FFF2-40B4-BE49-F238E27FC236}">
                <a16:creationId xmlns:a16="http://schemas.microsoft.com/office/drawing/2014/main" id="{F26A91D3-C28A-93DE-5659-AFC98CC5B3BD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509236" y="793469"/>
            <a:ext cx="2088000" cy="2951483"/>
          </a:xfrm>
          <a:prstGeom prst="rect">
            <a:avLst/>
          </a:prstGeom>
        </p:spPr>
      </p:pic>
      <p:pic>
        <p:nvPicPr>
          <p:cNvPr id="14" name="Picture 13" descr="Chao1_Female.png">
            <a:extLst>
              <a:ext uri="{FF2B5EF4-FFF2-40B4-BE49-F238E27FC236}">
                <a16:creationId xmlns:a16="http://schemas.microsoft.com/office/drawing/2014/main" id="{578DAA7F-2EF3-889C-BC19-5A5CEFC38D00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3064" y="3826868"/>
            <a:ext cx="2160000" cy="3053253"/>
          </a:xfrm>
          <a:prstGeom prst="rect">
            <a:avLst/>
          </a:prstGeom>
        </p:spPr>
      </p:pic>
      <p:pic>
        <p:nvPicPr>
          <p:cNvPr id="15" name="Picture 14" descr="Shannon_Female.png">
            <a:extLst>
              <a:ext uri="{FF2B5EF4-FFF2-40B4-BE49-F238E27FC236}">
                <a16:creationId xmlns:a16="http://schemas.microsoft.com/office/drawing/2014/main" id="{C6E52A3B-024E-4926-D1A8-C068294AA37D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348641" y="3814180"/>
            <a:ext cx="2160000" cy="3053253"/>
          </a:xfrm>
          <a:prstGeom prst="rect">
            <a:avLst/>
          </a:prstGeom>
        </p:spPr>
      </p:pic>
      <p:pic>
        <p:nvPicPr>
          <p:cNvPr id="16" name="Picture 15" descr="Simpson_0-3_years.png">
            <a:extLst>
              <a:ext uri="{FF2B5EF4-FFF2-40B4-BE49-F238E27FC236}">
                <a16:creationId xmlns:a16="http://schemas.microsoft.com/office/drawing/2014/main" id="{7EF6E4C4-51A5-23D3-FD08-B497DA959232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4506029" y="3814179"/>
            <a:ext cx="2160000" cy="3053253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A27D80F-0FAC-ACA9-D77A-7C502D5F65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992" y="3389440"/>
            <a:ext cx="3153600" cy="228364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FB0DEF1-3765-515B-B4ED-529AF2DBC82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3632" y="632521"/>
            <a:ext cx="3153600" cy="228364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BA443FF-830B-64B2-16EE-1D26B865D03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669273"/>
            <a:ext cx="3153600" cy="228364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7A04789-22D4-6640-5E27-DC47B6FB87D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24" y="3368825"/>
            <a:ext cx="3153600" cy="228364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01FD397-2907-B65F-DDC6-0A5963DC868E}"/>
              </a:ext>
            </a:extLst>
          </p:cNvPr>
          <p:cNvSpPr txBox="1"/>
          <p:nvPr/>
        </p:nvSpPr>
        <p:spPr>
          <a:xfrm>
            <a:off x="197820" y="7185248"/>
            <a:ext cx="6490073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 | Stratified analysis of Inflammatory marker levels in 0-3 years aged children compared between Healthy and SAM 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‑and‑jitter plots display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eloperoxidase (MPO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protectin (CAL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opterin (NEO, nmol/L), and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ory IgA (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A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g/kg), with each point representing one child; boxes denote the interquartile range with the median line and whiskers indicating distribution spread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s were calculated using the Wilcoxon rank-sum test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EA4DCEC-250B-224D-69AE-2738803CB2F7}"/>
              </a:ext>
            </a:extLst>
          </p:cNvPr>
          <p:cNvSpPr txBox="1"/>
          <p:nvPr/>
        </p:nvSpPr>
        <p:spPr>
          <a:xfrm>
            <a:off x="116632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32CEC76-3FCD-406B-7D68-9529DE234DB0}"/>
              </a:ext>
            </a:extLst>
          </p:cNvPr>
          <p:cNvSpPr txBox="1"/>
          <p:nvPr/>
        </p:nvSpPr>
        <p:spPr>
          <a:xfrm>
            <a:off x="3501008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6449FEE-D7E8-6CFE-ED36-CBFA958B111F}"/>
              </a:ext>
            </a:extLst>
          </p:cNvPr>
          <p:cNvSpPr txBox="1"/>
          <p:nvPr/>
        </p:nvSpPr>
        <p:spPr>
          <a:xfrm>
            <a:off x="188640" y="308079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016333B-4FDC-85AA-1516-97C4F68F52FB}"/>
              </a:ext>
            </a:extLst>
          </p:cNvPr>
          <p:cNvSpPr txBox="1"/>
          <p:nvPr/>
        </p:nvSpPr>
        <p:spPr>
          <a:xfrm>
            <a:off x="3501008" y="307150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2571541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1E450EE-CA4C-2F0C-9BC9-5B044C981C5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98" y="3296816"/>
            <a:ext cx="3151886" cy="2282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EE280D0-24C9-1861-29F0-A7C47CA825A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616" y="3296816"/>
            <a:ext cx="3151886" cy="2282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6A1E371-3B2D-D4A2-D639-323CA8E9F04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5089" y="632520"/>
            <a:ext cx="3151886" cy="2282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90C72BA-3107-E2AF-D849-A105E02E701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898" y="632520"/>
            <a:ext cx="3151886" cy="22824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423919B-9A9F-CD9E-CF51-41BFCE66C9EC}"/>
              </a:ext>
            </a:extLst>
          </p:cNvPr>
          <p:cNvSpPr txBox="1"/>
          <p:nvPr/>
        </p:nvSpPr>
        <p:spPr>
          <a:xfrm>
            <a:off x="116632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DA5B14-EC90-D7AF-656E-04B2976B9CBC}"/>
              </a:ext>
            </a:extLst>
          </p:cNvPr>
          <p:cNvSpPr txBox="1"/>
          <p:nvPr/>
        </p:nvSpPr>
        <p:spPr>
          <a:xfrm>
            <a:off x="3501008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7040E3-9E8B-5B50-8058-DA95D739BA33}"/>
              </a:ext>
            </a:extLst>
          </p:cNvPr>
          <p:cNvSpPr txBox="1"/>
          <p:nvPr/>
        </p:nvSpPr>
        <p:spPr>
          <a:xfrm>
            <a:off x="188640" y="308079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C7AA01-B075-D48D-3FF0-FE7BA46B8080}"/>
              </a:ext>
            </a:extLst>
          </p:cNvPr>
          <p:cNvSpPr txBox="1"/>
          <p:nvPr/>
        </p:nvSpPr>
        <p:spPr>
          <a:xfrm>
            <a:off x="3501008" y="307150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D71B535-EDE2-3D16-8E5B-67DBA86A4F7E}"/>
              </a:ext>
            </a:extLst>
          </p:cNvPr>
          <p:cNvSpPr txBox="1"/>
          <p:nvPr/>
        </p:nvSpPr>
        <p:spPr>
          <a:xfrm>
            <a:off x="197820" y="7185248"/>
            <a:ext cx="6490073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 | Stratified analysis of Inflammatory marker levels in 4-5 years aged children compared between Healthy and SAM 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‑and‑jitter plots display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eloperoxidase (MPO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protectin (CAL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opterin (NEO, nmol/L), and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ory IgA (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A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g/kg), with each point representing one child; boxes denote the interquartile range with the median line and whiskers indicating distribution spread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s were calculated using the Wilcoxon rank-sum test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772154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F87DBA6-B927-CAFE-0D37-7D40D0C8BC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356" y="56456"/>
            <a:ext cx="2228528" cy="391364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7E1D331-B4DD-3D9E-FCA5-3FFEE769170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797" y="56456"/>
            <a:ext cx="2224609" cy="39136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4433D8E-0E07-8D5F-1B2C-25AFBCAFECD4}"/>
              </a:ext>
            </a:extLst>
          </p:cNvPr>
          <p:cNvSpPr txBox="1"/>
          <p:nvPr/>
        </p:nvSpPr>
        <p:spPr>
          <a:xfrm>
            <a:off x="872454" y="3931878"/>
            <a:ext cx="2228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P-value= 0.001 </a:t>
            </a:r>
            <a:br>
              <a:rPr lang="en-IN" dirty="0"/>
            </a:br>
            <a:r>
              <a:rPr lang="en-IN" dirty="0"/>
              <a:t>q-value=0.1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0DF65B4-7567-122E-2056-5E597116C4CF}"/>
              </a:ext>
            </a:extLst>
          </p:cNvPr>
          <p:cNvSpPr txBox="1"/>
          <p:nvPr/>
        </p:nvSpPr>
        <p:spPr>
          <a:xfrm>
            <a:off x="3742465" y="3893659"/>
            <a:ext cx="2228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P-value= 0.02 </a:t>
            </a:r>
            <a:br>
              <a:rPr lang="en-IN" dirty="0"/>
            </a:br>
            <a:r>
              <a:rPr lang="en-IN" dirty="0"/>
              <a:t>q-value=0.37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313338F-32CF-611D-D97A-6C01258CB15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29" y="4557105"/>
            <a:ext cx="2228528" cy="39136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072C080-BCCC-0D96-27EB-531D538F2891}"/>
              </a:ext>
            </a:extLst>
          </p:cNvPr>
          <p:cNvSpPr txBox="1"/>
          <p:nvPr/>
        </p:nvSpPr>
        <p:spPr>
          <a:xfrm>
            <a:off x="764704" y="8405421"/>
            <a:ext cx="2228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P-value= &lt;0.0001 </a:t>
            </a:r>
            <a:br>
              <a:rPr lang="en-IN" dirty="0"/>
            </a:br>
            <a:r>
              <a:rPr lang="en-IN" dirty="0"/>
              <a:t>q-value=0.0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C055B85-532A-B2B7-584A-63166A517C7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9867" y="4527283"/>
            <a:ext cx="2147538" cy="391364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351DD27-3379-72B7-3C67-B37F8E86A29D}"/>
              </a:ext>
            </a:extLst>
          </p:cNvPr>
          <p:cNvSpPr txBox="1"/>
          <p:nvPr/>
        </p:nvSpPr>
        <p:spPr>
          <a:xfrm>
            <a:off x="3699474" y="8405420"/>
            <a:ext cx="2228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P-value= &lt;0.0001 </a:t>
            </a:r>
            <a:br>
              <a:rPr lang="en-IN" dirty="0"/>
            </a:br>
            <a:r>
              <a:rPr lang="en-IN" dirty="0"/>
              <a:t>q-value=0.0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DD473B-9ECA-5A36-3894-DFF7373E9C32}"/>
              </a:ext>
            </a:extLst>
          </p:cNvPr>
          <p:cNvSpPr txBox="1"/>
          <p:nvPr/>
        </p:nvSpPr>
        <p:spPr>
          <a:xfrm>
            <a:off x="183963" y="9066150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 | Relative abundance levels of significant bacterial genera compared between Healthy and SAM 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5826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_Blautia_single_regression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3152803"/>
            <a:ext cx="5157192" cy="2975173"/>
          </a:xfrm>
          <a:prstGeom prst="rect">
            <a:avLst/>
          </a:prstGeom>
        </p:spPr>
      </p:pic>
      <p:pic>
        <p:nvPicPr>
          <p:cNvPr id="8" name="Picture 7" descr="g_Akkermansia_single_regression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128464"/>
            <a:ext cx="5013176" cy="2779716"/>
          </a:xfrm>
          <a:prstGeom prst="rect">
            <a:avLst/>
          </a:prstGeom>
        </p:spPr>
      </p:pic>
      <p:pic>
        <p:nvPicPr>
          <p:cNvPr id="9" name="Picture 8" descr="g_Clostridium_sensu_stricto_1_single_regression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6128480"/>
            <a:ext cx="5301208" cy="292897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A818FD1-D78F-3EB3-A54D-848FF451C93F}"/>
              </a:ext>
            </a:extLst>
          </p:cNvPr>
          <p:cNvSpPr txBox="1"/>
          <p:nvPr/>
        </p:nvSpPr>
        <p:spPr>
          <a:xfrm>
            <a:off x="183963" y="9066150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 | Linear regression between bacterial genera abundance and WHZ scores, stratified by age, gender, and nutritional status.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g_Clostridium_sensu_stricto_1_single_regression.png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0" y="-15552"/>
            <a:ext cx="5301208" cy="2880320"/>
          </a:xfrm>
        </p:spPr>
      </p:pic>
      <p:pic>
        <p:nvPicPr>
          <p:cNvPr id="5" name="Picture 4" descr="g_Colidextribacter_single_regression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2900264"/>
            <a:ext cx="5373216" cy="3096344"/>
          </a:xfrm>
          <a:prstGeom prst="rect">
            <a:avLst/>
          </a:prstGeom>
        </p:spPr>
      </p:pic>
      <p:pic>
        <p:nvPicPr>
          <p:cNvPr id="6" name="Picture 5" descr="g_Enterococcus_single_regression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5996608"/>
            <a:ext cx="5445224" cy="298782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1FADB28-4A1D-3165-2F86-4E7A29147AAF}"/>
              </a:ext>
            </a:extLst>
          </p:cNvPr>
          <p:cNvSpPr txBox="1"/>
          <p:nvPr/>
        </p:nvSpPr>
        <p:spPr>
          <a:xfrm>
            <a:off x="183963" y="9070230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 | Linear regression between bacterial genera abundance and WHZ scores, stratified by age, gender, and nutritional status.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_Erysipelatoclostridium_single_regression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-15552"/>
            <a:ext cx="5373216" cy="2477383"/>
          </a:xfrm>
          <a:prstGeom prst="rect">
            <a:avLst/>
          </a:prstGeom>
        </p:spPr>
      </p:pic>
      <p:pic>
        <p:nvPicPr>
          <p:cNvPr id="5" name="Picture 4" descr="g_Erysipelotrichaceae_UCG-003_single_regression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2540221"/>
            <a:ext cx="5445224" cy="3168352"/>
          </a:xfrm>
          <a:prstGeom prst="rect">
            <a:avLst/>
          </a:prstGeom>
        </p:spPr>
      </p:pic>
      <p:pic>
        <p:nvPicPr>
          <p:cNvPr id="7" name="Picture 6" descr="g_Fusobacterium_single_regression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5829679"/>
            <a:ext cx="5517232" cy="30472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B24451E-D9EE-D2E6-337A-E1DCF4B90962}"/>
              </a:ext>
            </a:extLst>
          </p:cNvPr>
          <p:cNvSpPr txBox="1"/>
          <p:nvPr/>
        </p:nvSpPr>
        <p:spPr>
          <a:xfrm>
            <a:off x="183963" y="8913440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 | Linear regression between bacterial genera abundance and WHZ scores, stratified by age, gender, and nutritional status.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_Limosilactobacillus_single_regression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-15552"/>
            <a:ext cx="5589240" cy="2699792"/>
          </a:xfrm>
          <a:prstGeom prst="rect">
            <a:avLst/>
          </a:prstGeom>
        </p:spPr>
      </p:pic>
      <p:pic>
        <p:nvPicPr>
          <p:cNvPr id="6" name="Picture 5" descr="g_Megamonas_single_regression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2756249"/>
            <a:ext cx="5661248" cy="3240360"/>
          </a:xfrm>
          <a:prstGeom prst="rect">
            <a:avLst/>
          </a:prstGeom>
        </p:spPr>
      </p:pic>
      <p:pic>
        <p:nvPicPr>
          <p:cNvPr id="7" name="Picture 6" descr="g_Parabacteroides_single_regression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5996608"/>
            <a:ext cx="5661248" cy="302433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66B2D83-1251-AA5B-0020-132E2189037E}"/>
              </a:ext>
            </a:extLst>
          </p:cNvPr>
          <p:cNvSpPr txBox="1"/>
          <p:nvPr/>
        </p:nvSpPr>
        <p:spPr>
          <a:xfrm>
            <a:off x="183963" y="8985448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 | Linear regression between bacterial genera abundance and WHZ scores, stratified by age, gender, and nutritional status.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_Staphylococcus_single_regression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6632" y="20958"/>
            <a:ext cx="5544616" cy="2664296"/>
          </a:xfrm>
          <a:prstGeom prst="rect">
            <a:avLst/>
          </a:prstGeom>
        </p:spPr>
      </p:pic>
      <p:pic>
        <p:nvPicPr>
          <p:cNvPr id="5" name="Picture 4" descr="g_Succinivibrio_single_regression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2685254"/>
            <a:ext cx="5805264" cy="3024336"/>
          </a:xfrm>
          <a:prstGeom prst="rect">
            <a:avLst/>
          </a:prstGeom>
        </p:spPr>
      </p:pic>
      <p:pic>
        <p:nvPicPr>
          <p:cNvPr id="6" name="Picture 5" descr="g_Turicibacter_single_regression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5758687"/>
            <a:ext cx="5805264" cy="329876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68C44B-437E-770E-8F4B-67F48B2A589E}"/>
              </a:ext>
            </a:extLst>
          </p:cNvPr>
          <p:cNvSpPr txBox="1"/>
          <p:nvPr/>
        </p:nvSpPr>
        <p:spPr>
          <a:xfrm>
            <a:off x="183963" y="8985448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 | Linear regression between bacterial genera abundance and WHZ scores, stratified by age, gender, and nutritional status.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_Tyzzerella_single_regression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560512"/>
            <a:ext cx="5517232" cy="338437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D2DD9AE-19AB-5297-AA57-388D98140A5A}"/>
              </a:ext>
            </a:extLst>
          </p:cNvPr>
          <p:cNvSpPr txBox="1"/>
          <p:nvPr/>
        </p:nvSpPr>
        <p:spPr>
          <a:xfrm>
            <a:off x="183963" y="4304928"/>
            <a:ext cx="649007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 | Linear regression between bacterial genera abundance and WHZ scores, stratified by age, gender, and nutritional statu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CC6098E-0C4A-00CA-5112-0BCB31221DAF}"/>
              </a:ext>
            </a:extLst>
          </p:cNvPr>
          <p:cNvSpPr txBox="1"/>
          <p:nvPr/>
        </p:nvSpPr>
        <p:spPr>
          <a:xfrm>
            <a:off x="188640" y="58257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E492731-E7B7-34AE-774B-6237B2266532}"/>
              </a:ext>
            </a:extLst>
          </p:cNvPr>
          <p:cNvSpPr txBox="1"/>
          <p:nvPr/>
        </p:nvSpPr>
        <p:spPr>
          <a:xfrm>
            <a:off x="116632" y="335953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FC1DC89-0686-A8B8-5D6D-9A3374A1A547}"/>
              </a:ext>
            </a:extLst>
          </p:cNvPr>
          <p:cNvSpPr txBox="1"/>
          <p:nvPr/>
        </p:nvSpPr>
        <p:spPr>
          <a:xfrm>
            <a:off x="220544" y="7473283"/>
            <a:ext cx="6336704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| Stratified analysis of alpha diversity by age group in healthy and SAM children.</a:t>
            </a:r>
            <a:b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plots depicting alpha diversity metrics (Chao1, Shannon, and Simpson indices) in children age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–3 year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ross healthy and SAM group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sponding alpha diversity comparisons in children age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–5 year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xplots show the median, interquartile range (IQR), and individual data points. P values were calculated using the Wilcoxon rank-sum test.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 descr="Chao1_0-3_years.png">
            <a:extLst>
              <a:ext uri="{FF2B5EF4-FFF2-40B4-BE49-F238E27FC236}">
                <a16:creationId xmlns:a16="http://schemas.microsoft.com/office/drawing/2014/main" id="{2EE94074-2F49-D283-C4F2-4A7E13F08961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78865" y="490946"/>
            <a:ext cx="2160000" cy="3053253"/>
          </a:xfrm>
          <a:prstGeom prst="rect">
            <a:avLst/>
          </a:prstGeom>
        </p:spPr>
      </p:pic>
      <p:pic>
        <p:nvPicPr>
          <p:cNvPr id="6" name="Picture 5" descr="Shannon_0-3_years.png">
            <a:extLst>
              <a:ext uri="{FF2B5EF4-FFF2-40B4-BE49-F238E27FC236}">
                <a16:creationId xmlns:a16="http://schemas.microsoft.com/office/drawing/2014/main" id="{70817401-75AA-4C5D-899A-8E3029DF6C61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438865" y="489611"/>
            <a:ext cx="2160000" cy="3053253"/>
          </a:xfrm>
          <a:prstGeom prst="rect">
            <a:avLst/>
          </a:prstGeom>
        </p:spPr>
      </p:pic>
      <p:pic>
        <p:nvPicPr>
          <p:cNvPr id="7" name="Picture 6" descr="Simpson_0-3_years.png">
            <a:extLst>
              <a:ext uri="{FF2B5EF4-FFF2-40B4-BE49-F238E27FC236}">
                <a16:creationId xmlns:a16="http://schemas.microsoft.com/office/drawing/2014/main" id="{A13B0B47-0F5B-2770-76BE-82ED9D92CDA4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598865" y="489611"/>
            <a:ext cx="2160000" cy="305325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FD2AC19-D704-FB3D-A929-843557D37FB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1368" y="3744849"/>
            <a:ext cx="2160000" cy="305325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86C7502-D987-8253-61C1-6AE72CB7553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545" y="3699294"/>
            <a:ext cx="2160001" cy="305325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994372B-6434-EE7E-2F20-BD4C432DA44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0834" y="3744849"/>
            <a:ext cx="2160001" cy="3053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134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lefse_male_portrait_highdpi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-127428" y="1057109"/>
            <a:ext cx="3542848" cy="4608512"/>
          </a:xfrm>
          <a:prstGeom prst="rect">
            <a:avLst/>
          </a:prstGeom>
        </p:spPr>
      </p:pic>
      <p:pic>
        <p:nvPicPr>
          <p:cNvPr id="5" name="Picture 4" descr="lefse_female_portrait_highdpi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284984" y="1064568"/>
            <a:ext cx="3391272" cy="460851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214F401-88EB-E885-0605-FB965F8EC681}"/>
              </a:ext>
            </a:extLst>
          </p:cNvPr>
          <p:cNvSpPr txBox="1"/>
          <p:nvPr/>
        </p:nvSpPr>
        <p:spPr>
          <a:xfrm>
            <a:off x="188640" y="683209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8122FDF-D269-28A6-2DC9-BAF3EF26BEB6}"/>
              </a:ext>
            </a:extLst>
          </p:cNvPr>
          <p:cNvSpPr txBox="1"/>
          <p:nvPr/>
        </p:nvSpPr>
        <p:spPr>
          <a:xfrm>
            <a:off x="3645024" y="67474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F953D2-B6B5-044D-D916-794DB94142D9}"/>
              </a:ext>
            </a:extLst>
          </p:cNvPr>
          <p:cNvSpPr txBox="1"/>
          <p:nvPr/>
        </p:nvSpPr>
        <p:spPr>
          <a:xfrm>
            <a:off x="188640" y="7329267"/>
            <a:ext cx="6487616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| Differentially abundant genera identified by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stratified by gender in healthy and SAM children.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ar Discriminant Analysis Effect Size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ot of differentially abundant bacterial genera i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childre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DA score threshold = 3). Genera enriched in healthy children are shown in green, and those enriched in SAM children are shown in orange.</a:t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sponding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childre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lefse_age0-3_portrait_highdpi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776536"/>
            <a:ext cx="3240360" cy="4536504"/>
          </a:xfrm>
          <a:prstGeom prst="rect">
            <a:avLst/>
          </a:prstGeom>
        </p:spPr>
      </p:pic>
      <p:pic>
        <p:nvPicPr>
          <p:cNvPr id="7" name="Picture 6" descr="lefse_age3-5_portrait_highdpi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395724" y="776536"/>
            <a:ext cx="3384376" cy="4572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CBB98DB-FCFA-7CCE-3373-49B21D3B9255}"/>
              </a:ext>
            </a:extLst>
          </p:cNvPr>
          <p:cNvSpPr txBox="1"/>
          <p:nvPr/>
        </p:nvSpPr>
        <p:spPr>
          <a:xfrm>
            <a:off x="188640" y="683209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0DA5BF-15B4-B0C5-A0EA-29BC7B7986C3}"/>
              </a:ext>
            </a:extLst>
          </p:cNvPr>
          <p:cNvSpPr txBox="1"/>
          <p:nvPr/>
        </p:nvSpPr>
        <p:spPr>
          <a:xfrm>
            <a:off x="3645024" y="67474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E6906B-7AE0-F09F-4CA8-A209DED51694}"/>
              </a:ext>
            </a:extLst>
          </p:cNvPr>
          <p:cNvSpPr txBox="1"/>
          <p:nvPr/>
        </p:nvSpPr>
        <p:spPr>
          <a:xfrm>
            <a:off x="219913" y="7396460"/>
            <a:ext cx="6469756" cy="17235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| Differentially abundant genera identified by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stratified by age in healthy and SAM children.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ar Discriminant Analysis Effect Size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ot of differentially abundant bacterial genera in children age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–3 year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DA score threshold = 3). Genera enriched in healthy children are shown in green, while those enriched in SAM children are shown in orange.</a:t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sponding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children age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–5 year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2513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3EBD9D3-329E-CDA8-5E3C-7E58EAE7D34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32" y="382336"/>
            <a:ext cx="4785360" cy="658688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A26FE86-B1E6-BBFF-6981-1E14BFC6AE0F}"/>
              </a:ext>
            </a:extLst>
          </p:cNvPr>
          <p:cNvSpPr txBox="1"/>
          <p:nvPr/>
        </p:nvSpPr>
        <p:spPr>
          <a:xfrm>
            <a:off x="97823" y="7218601"/>
            <a:ext cx="6624735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| Spearman correlation analysis of bacterial genera and clinical, dietary, and inflammatory parameters in SAM children.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correlation analysis was performed on bacterial genera with a prevalence of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50%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 significant difference in the Mann–Whitney U test between the healthy and SAM groups, focusing exclusively o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 subjec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heatmap shows the strength and direction of correlations, with the color gradient representing positive (green) or negative (blue) associations. The symbols indicate statistical significance: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#’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1 an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●’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 All other associations are non-significant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1555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64F6CF8-8C28-3A25-7944-8071A905096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32" y="488505"/>
            <a:ext cx="4608512" cy="634346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F8F4B7-3F1A-B4C9-904D-64596027ACA2}"/>
              </a:ext>
            </a:extLst>
          </p:cNvPr>
          <p:cNvSpPr txBox="1"/>
          <p:nvPr/>
        </p:nvSpPr>
        <p:spPr>
          <a:xfrm>
            <a:off x="116633" y="6986062"/>
            <a:ext cx="6490073" cy="24314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 | Spearman correlation analysis of bacterial genera and clinical, dietary, and inflammatory parameters in healthy children.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correlation analysis was performed on bacterial genera with a prevalence of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50%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 significant difference in the Mann–Whitney U test between the healthy and SAM groups, focusing exclusively o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 subjec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heatmap illustrates the strength and direction of correlations, with the color gradient representing positive (green) and negative (blue) associations. Symbols indicate statistical significance: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#’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1 and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●’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 Non-significant associations are shown without markers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35927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8CA7728-630F-EF9F-C9DB-7DFBB891B68C}"/>
              </a:ext>
            </a:extLst>
          </p:cNvPr>
          <p:cNvSpPr txBox="1"/>
          <p:nvPr/>
        </p:nvSpPr>
        <p:spPr>
          <a:xfrm>
            <a:off x="260649" y="7175235"/>
            <a:ext cx="6490073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 | Inflammatory marker levels compared between Healthy and SAM children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‑and‑jitter plots display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eloperoxidase (MPO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protectin (CAL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opterin (NEO, nmol/L), and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cretory IgA (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A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g/kg), with each point representing one child; boxes denote the interquartile range with the median line and whiskers indicating distribution spread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s were calculated using the Wilcoxon rank-sum test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AD04C4E-BEEF-B009-5964-84D996F8D50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120" y="730217"/>
            <a:ext cx="3148964" cy="228028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9CF1C00-9906-6F21-46B7-34B0E5B7921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1084" y="730217"/>
            <a:ext cx="3148964" cy="228028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5D9E635-ECD4-0F45-E62B-48F9B550416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12" y="3440833"/>
            <a:ext cx="3148965" cy="228028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40968BC-854D-29B4-040A-E005F75FE9D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0008" y="3431064"/>
            <a:ext cx="3148964" cy="22802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C63C819-4848-BC99-044D-0E71E8757044}"/>
              </a:ext>
            </a:extLst>
          </p:cNvPr>
          <p:cNvSpPr txBox="1"/>
          <p:nvPr/>
        </p:nvSpPr>
        <p:spPr>
          <a:xfrm>
            <a:off x="116632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D76F556-178C-A34B-C401-9FC187FC123A}"/>
              </a:ext>
            </a:extLst>
          </p:cNvPr>
          <p:cNvSpPr txBox="1"/>
          <p:nvPr/>
        </p:nvSpPr>
        <p:spPr>
          <a:xfrm>
            <a:off x="3501008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EB10B6B-46DA-94D2-8B5E-D378F3800CE3}"/>
              </a:ext>
            </a:extLst>
          </p:cNvPr>
          <p:cNvSpPr txBox="1"/>
          <p:nvPr/>
        </p:nvSpPr>
        <p:spPr>
          <a:xfrm>
            <a:off x="188640" y="308079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DEF1A5-E659-E7CC-5A8A-300E8A801E22}"/>
              </a:ext>
            </a:extLst>
          </p:cNvPr>
          <p:cNvSpPr txBox="1"/>
          <p:nvPr/>
        </p:nvSpPr>
        <p:spPr>
          <a:xfrm>
            <a:off x="3501008" y="307150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6063895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24CD67A-AB81-F1DA-C544-DA4C6AC8BF63}"/>
              </a:ext>
            </a:extLst>
          </p:cNvPr>
          <p:cNvSpPr txBox="1"/>
          <p:nvPr/>
        </p:nvSpPr>
        <p:spPr>
          <a:xfrm>
            <a:off x="260649" y="7175235"/>
            <a:ext cx="6490073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 | Stratified analysis of Inflammatory marker levels in female children compared between Healthy and SAM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‑and‑jitter plots display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eloperoxidase (MPO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lprotectin (CAL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opterin (NEO, nmol/L), and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ory IgA (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A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g/kg), with each point representing one child; boxes denote the interquartile range with the median line and whiskers indicating distribution spread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s were calculated using the Wilcoxon rank-sum test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A0BBC98-B301-2CE6-3E08-6042F101FE4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730218"/>
            <a:ext cx="3150000" cy="228103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637F159-5E85-CF22-AFEB-D45C2D4C71C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4984" y="756258"/>
            <a:ext cx="3150000" cy="228103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7BE3D22-28E7-0585-CD03-38B04B43F96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24" y="3309650"/>
            <a:ext cx="3150000" cy="228103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7F1CEB2-8124-C142-33D4-BC09596C8BB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6736" y="3309649"/>
            <a:ext cx="3150000" cy="228103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0A5EA4-A484-85D8-9529-87A5F6BC5463}"/>
              </a:ext>
            </a:extLst>
          </p:cNvPr>
          <p:cNvSpPr txBox="1"/>
          <p:nvPr/>
        </p:nvSpPr>
        <p:spPr>
          <a:xfrm>
            <a:off x="116632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60A57C2-4791-B754-D6C4-6A55B891D7FE}"/>
              </a:ext>
            </a:extLst>
          </p:cNvPr>
          <p:cNvSpPr txBox="1"/>
          <p:nvPr/>
        </p:nvSpPr>
        <p:spPr>
          <a:xfrm>
            <a:off x="3501008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D2174E-38E3-505E-C130-C2DE742331FE}"/>
              </a:ext>
            </a:extLst>
          </p:cNvPr>
          <p:cNvSpPr txBox="1"/>
          <p:nvPr/>
        </p:nvSpPr>
        <p:spPr>
          <a:xfrm>
            <a:off x="188640" y="308079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F58F53-127A-9278-C001-267CCCDFE608}"/>
              </a:ext>
            </a:extLst>
          </p:cNvPr>
          <p:cNvSpPr txBox="1"/>
          <p:nvPr/>
        </p:nvSpPr>
        <p:spPr>
          <a:xfrm>
            <a:off x="3501008" y="307150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516952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5656739-BB5E-7F91-DE41-107303425CA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24" y="3150592"/>
            <a:ext cx="3151886" cy="2282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1D2E953-9402-63AE-CDFE-EBF2F86E7B0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0262" y="3150592"/>
            <a:ext cx="3151886" cy="2282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317CD36-03DF-3407-32F3-BEA5E46A393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856" y="632520"/>
            <a:ext cx="3151886" cy="2282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16D3E8E-58C4-AD8C-1372-72F2AEC2CE5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632520"/>
            <a:ext cx="3151886" cy="22824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68E92EC-DC5E-F823-6BEA-49A4672DA44E}"/>
              </a:ext>
            </a:extLst>
          </p:cNvPr>
          <p:cNvSpPr txBox="1"/>
          <p:nvPr/>
        </p:nvSpPr>
        <p:spPr>
          <a:xfrm>
            <a:off x="197820" y="7185248"/>
            <a:ext cx="6490073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 | Stratified analysis of Inflammatory marker levels in male children compared between Healthy and SAM </a:t>
            </a:r>
            <a:b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‑and‑jitter plots display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yeloperoxidase (MPO, mg/kg),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protectin (CAL, mg/kg),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opterin (NEO, nmol/L), and </a:t>
            </a:r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retory IgA (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A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g/kg), with each point representing one child; boxes denote the interquartile range with the median line and whiskers indicating distribution spread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values were calculated using the Wilcoxon rank-sum test.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0F7A2C2-BC77-4836-0D53-4E2D718F2B99}"/>
              </a:ext>
            </a:extLst>
          </p:cNvPr>
          <p:cNvSpPr txBox="1"/>
          <p:nvPr/>
        </p:nvSpPr>
        <p:spPr>
          <a:xfrm>
            <a:off x="116632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B0D0B72-10BA-3D32-64E9-2D90D402F735}"/>
              </a:ext>
            </a:extLst>
          </p:cNvPr>
          <p:cNvSpPr txBox="1"/>
          <p:nvPr/>
        </p:nvSpPr>
        <p:spPr>
          <a:xfrm>
            <a:off x="3501008" y="41649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4558CF-9C8B-09A9-6462-617A2CA66DDC}"/>
              </a:ext>
            </a:extLst>
          </p:cNvPr>
          <p:cNvSpPr txBox="1"/>
          <p:nvPr/>
        </p:nvSpPr>
        <p:spPr>
          <a:xfrm>
            <a:off x="188640" y="287406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6C1AFA-46A2-BE5F-593C-9FE8C6D1070D}"/>
              </a:ext>
            </a:extLst>
          </p:cNvPr>
          <p:cNvSpPr txBox="1"/>
          <p:nvPr/>
        </p:nvSpPr>
        <p:spPr>
          <a:xfrm>
            <a:off x="3501008" y="286476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589769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72</TotalTime>
  <Words>1276</Words>
  <Application>Microsoft Office PowerPoint</Application>
  <PresentationFormat>A4 Paper (210x297 mm)</PresentationFormat>
  <Paragraphs>55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ttarakhand NIN</dc:creator>
  <cp:lastModifiedBy>PARTH SARIN</cp:lastModifiedBy>
  <cp:revision>31</cp:revision>
  <dcterms:created xsi:type="dcterms:W3CDTF">2025-08-28T06:07:31Z</dcterms:created>
  <dcterms:modified xsi:type="dcterms:W3CDTF">2025-11-04T11:28:30Z</dcterms:modified>
</cp:coreProperties>
</file>